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9" r:id="rId6"/>
    <p:sldId id="270" r:id="rId7"/>
    <p:sldId id="271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67" d="100"/>
          <a:sy n="67" d="100"/>
        </p:scale>
        <p:origin x="1652" y="4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8/30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8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schemia-guided versus routine non-culprit vessel angioplasty for patients with ST segment elevation myocardial infarction and multi-vessel disease - the IAEA SPECT STEMI trial</a:t>
            </a:r>
            <a:endParaRPr lang="en-US" altLang="en-US" sz="2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800" dirty="0">
                <a:latin typeface="Calibri" panose="020F0502020204030204" pitchFamily="34" charset="0"/>
                <a:cs typeface="Calibri" panose="020F0502020204030204" pitchFamily="34" charset="0"/>
              </a:rPr>
              <a:t>Karthikeyan G, </a:t>
            </a:r>
            <a:r>
              <a:rPr lang="en-US" altLang="en-US" sz="1800" dirty="0" err="1">
                <a:latin typeface="Calibri" panose="020F0502020204030204" pitchFamily="34" charset="0"/>
                <a:cs typeface="Calibri" panose="020F0502020204030204" pitchFamily="34" charset="0"/>
              </a:rPr>
              <a:t>Piex</a:t>
            </a:r>
            <a:r>
              <a:rPr lang="en-US" altLang="en-US" sz="1800" dirty="0">
                <a:latin typeface="Calibri" panose="020F0502020204030204" pitchFamily="34" charset="0"/>
                <a:cs typeface="Calibri" panose="020F0502020204030204" pitchFamily="34" charset="0"/>
              </a:rPr>
              <a:t> A, Devasenapathy N, et al.</a:t>
            </a:r>
          </a:p>
          <a:p>
            <a:pPr marL="0" lvl="1"/>
            <a:r>
              <a:rPr lang="en-US" altLang="en-US" sz="1800" dirty="0">
                <a:latin typeface="Calibri" panose="020F0502020204030204" pitchFamily="34" charset="0"/>
                <a:cs typeface="Calibri" panose="020F0502020204030204" pitchFamily="34" charset="0"/>
              </a:rPr>
              <a:t>All India Institute of Medical Sciences, New Delhi, India</a:t>
            </a:r>
          </a:p>
          <a:p>
            <a:pPr marL="0" lvl="1"/>
            <a:r>
              <a:rPr lang="en-US" altLang="en-US" sz="1800" dirty="0">
                <a:latin typeface="Calibri" panose="020F0502020204030204" pitchFamily="34" charset="0"/>
                <a:cs typeface="Calibri" panose="020F0502020204030204" pitchFamily="34" charset="0"/>
              </a:rPr>
              <a:t>Funded by the International Atomic Energy Agency, Vienna</a:t>
            </a:r>
          </a:p>
          <a:p>
            <a:endParaRPr lang="en-US" altLang="en-US" sz="1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A person wearing glasses&#10;&#10;Description automatically generated with medium confidence">
            <a:extLst>
              <a:ext uri="{FF2B5EF4-FFF2-40B4-BE49-F238E27FC236}">
                <a16:creationId xmlns:a16="http://schemas.microsoft.com/office/drawing/2014/main" id="{835ECA7B-79EB-34C3-5EF5-D12EEDA7B49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9200" y="4095750"/>
            <a:ext cx="1905000" cy="1905000"/>
          </a:xfrm>
          <a:prstGeom prst="rect">
            <a:avLst/>
          </a:prstGeom>
        </p:spPr>
      </p:pic>
      <p:pic>
        <p:nvPicPr>
          <p:cNvPr id="6" name="Picture 2">
            <a:extLst>
              <a:ext uri="{FF2B5EF4-FFF2-40B4-BE49-F238E27FC236}">
                <a16:creationId xmlns:a16="http://schemas.microsoft.com/office/drawing/2014/main" id="{44816D04-BC7A-BC1F-CE39-A887215DEAD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6109607" y="3979522"/>
            <a:ext cx="1905000" cy="21374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Calibri" panose="020F0502020204030204" pitchFamily="34" charset="0"/>
                <a:cs typeface="Calibri" panose="020F0502020204030204" pitchFamily="34" charset="0"/>
              </a:rPr>
              <a:t>BACKGROUND</a:t>
            </a:r>
            <a:endParaRPr lang="en-US" sz="3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Current guidelines recommend routine non-culprit PCI after primary PCI for STEMI with multivessel disease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However, in the trials on which these recommendations are based, systematic ischemia testing has generally not been performed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Data suggest that only about half of the angiographically significant lesions in non-culprit vessels are physiologically significant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We hypothesized that, a strategy of systematic non-invasive assessment for inducible ischemia to guide decisions regarding non-culprit PCI, will be non-inferior to routine non-culprit PCI, in reducing ischemia burden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Calibri" panose="020F0502020204030204" pitchFamily="34" charset="0"/>
                <a:cs typeface="Calibri" panose="020F0502020204030204" pitchFamily="34" charset="0"/>
              </a:rPr>
              <a:t>METHODS</a:t>
            </a:r>
            <a:endParaRPr lang="en-US" sz="3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altLang="en-US" sz="2400" b="1" dirty="0">
                <a:latin typeface="Calibri" panose="020F0502020204030204" pitchFamily="34" charset="0"/>
                <a:cs typeface="Calibri" panose="020F0502020204030204" pitchFamily="34" charset="0"/>
              </a:rPr>
              <a:t>Design</a:t>
            </a: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: International, multicenter, open-label, randomized, non-inferiority trial</a:t>
            </a:r>
          </a:p>
          <a:p>
            <a:r>
              <a:rPr lang="en-US" altLang="en-US" sz="2400" b="1" dirty="0">
                <a:latin typeface="Calibri" panose="020F0502020204030204" pitchFamily="34" charset="0"/>
                <a:cs typeface="Calibri" panose="020F0502020204030204" pitchFamily="34" charset="0"/>
              </a:rPr>
              <a:t>Study subjects</a:t>
            </a: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: Age ≥18 years, successful primary PCI for a first STEMI, and had a significant stenosis (≥70% diameter stenosis) in at least one non-infarct-related coronary artery, or major side branch (≥ 2.5mm diameter). We excluded those with left-main disease, mechanical complications following MI, and hemodynamically unstable patients</a:t>
            </a:r>
          </a:p>
          <a:p>
            <a:r>
              <a:rPr lang="en-US" altLang="en-US" sz="2400" b="1" dirty="0">
                <a:latin typeface="Calibri" panose="020F0502020204030204" pitchFamily="34" charset="0"/>
                <a:cs typeface="Calibri" panose="020F0502020204030204" pitchFamily="34" charset="0"/>
              </a:rPr>
              <a:t>Interventions</a:t>
            </a: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: Routine non-culprit PCI within 6 weeks vs. PCI guided by vasodilator stress MPI within 7 days of index STEMI</a:t>
            </a:r>
          </a:p>
          <a:p>
            <a:r>
              <a:rPr lang="en-US" altLang="en-US" sz="2400" b="1" dirty="0">
                <a:latin typeface="Calibri" panose="020F0502020204030204" pitchFamily="34" charset="0"/>
                <a:cs typeface="Calibri" panose="020F0502020204030204" pitchFamily="34" charset="0"/>
              </a:rPr>
              <a:t>Primary outcome</a:t>
            </a: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: Between-group difference in percent ischemic myocardium at follow-up imaging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15344095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762000"/>
            <a:ext cx="8229600" cy="655638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Calibri" panose="020F0502020204030204" pitchFamily="34" charset="0"/>
                <a:cs typeface="Calibri" panose="020F0502020204030204" pitchFamily="34" charset="0"/>
              </a:rPr>
              <a:t>RESULTS</a:t>
            </a:r>
            <a:endParaRPr lang="en-US" sz="3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767E58B2-5147-7DFB-BB3E-B1B7C1111CC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8221697"/>
              </p:ext>
            </p:extLst>
          </p:nvPr>
        </p:nvGraphicFramePr>
        <p:xfrm>
          <a:off x="533400" y="1920240"/>
          <a:ext cx="8077200" cy="301752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133664">
                  <a:extLst>
                    <a:ext uri="{9D8B030D-6E8A-4147-A177-3AD203B41FA5}">
                      <a16:colId xmlns:a16="http://schemas.microsoft.com/office/drawing/2014/main" val="803820092"/>
                    </a:ext>
                  </a:extLst>
                </a:gridCol>
                <a:gridCol w="1489373">
                  <a:extLst>
                    <a:ext uri="{9D8B030D-6E8A-4147-A177-3AD203B41FA5}">
                      <a16:colId xmlns:a16="http://schemas.microsoft.com/office/drawing/2014/main" val="295651371"/>
                    </a:ext>
                  </a:extLst>
                </a:gridCol>
                <a:gridCol w="1574207">
                  <a:extLst>
                    <a:ext uri="{9D8B030D-6E8A-4147-A177-3AD203B41FA5}">
                      <a16:colId xmlns:a16="http://schemas.microsoft.com/office/drawing/2014/main" val="1069798846"/>
                    </a:ext>
                  </a:extLst>
                </a:gridCol>
                <a:gridCol w="1623599">
                  <a:extLst>
                    <a:ext uri="{9D8B030D-6E8A-4147-A177-3AD203B41FA5}">
                      <a16:colId xmlns:a16="http://schemas.microsoft.com/office/drawing/2014/main" val="2847321481"/>
                    </a:ext>
                  </a:extLst>
                </a:gridCol>
                <a:gridCol w="1256357">
                  <a:extLst>
                    <a:ext uri="{9D8B030D-6E8A-4147-A177-3AD203B41FA5}">
                      <a16:colId xmlns:a16="http://schemas.microsoft.com/office/drawing/2014/main" val="3829247158"/>
                    </a:ext>
                  </a:extLst>
                </a:gridCol>
              </a:tblGrid>
              <a:tr h="1258671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utcome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4686" marR="346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Ischemia guided PCI arm (n=43)</a:t>
                      </a:r>
                      <a:endParaRPr lang="en-US" sz="1800"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4686" marR="346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outine non-culprit (n=40)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4686" marR="346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djusted median difference (Quantile regression) (95% CI)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4686" marR="346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 value for non-inferiority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4686" marR="34686" marT="0" marB="0"/>
                </a:tc>
                <a:extLst>
                  <a:ext uri="{0D108BD9-81ED-4DB2-BD59-A6C34878D82A}">
                    <a16:rowId xmlns:a16="http://schemas.microsoft.com/office/drawing/2014/main" val="2652082121"/>
                  </a:ext>
                </a:extLst>
              </a:tr>
              <a:tr h="1131491"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edian % ischemic myocardium</a:t>
                      </a:r>
                      <a:endParaRPr lang="en-US" sz="18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 b="0" dirty="0"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Interquartile range)- Intention-to-treat analysis</a:t>
                      </a:r>
                      <a:endParaRPr lang="en-US" sz="18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4686" marR="346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 b="1" dirty="0">
                          <a:solidFill>
                            <a:schemeClr val="accent2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94 </a:t>
                      </a:r>
                    </a:p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 b="1" dirty="0">
                          <a:solidFill>
                            <a:schemeClr val="accent2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0, 5.9)</a:t>
                      </a:r>
                      <a:endParaRPr lang="en-US" sz="1800" b="1" dirty="0">
                        <a:solidFill>
                          <a:schemeClr val="accent2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4686" marR="346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 b="1" dirty="0">
                          <a:solidFill>
                            <a:schemeClr val="accent2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.94 </a:t>
                      </a:r>
                    </a:p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 b="1" dirty="0">
                          <a:solidFill>
                            <a:schemeClr val="accent2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0, 4.41)</a:t>
                      </a:r>
                      <a:endParaRPr lang="en-US" sz="1800" b="1" dirty="0">
                        <a:solidFill>
                          <a:schemeClr val="accent2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4686" marR="346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 b="1" dirty="0">
                          <a:solidFill>
                            <a:schemeClr val="accent2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13 </a:t>
                      </a:r>
                    </a:p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 b="1" dirty="0">
                          <a:solidFill>
                            <a:schemeClr val="accent2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-1.32, 1.60)</a:t>
                      </a:r>
                      <a:endParaRPr lang="en-US" sz="1800" b="1" dirty="0">
                        <a:solidFill>
                          <a:schemeClr val="accent2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4686" marR="346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N" sz="1800" b="1" dirty="0">
                          <a:solidFill>
                            <a:schemeClr val="accent2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&lt;0.0001</a:t>
                      </a:r>
                      <a:endParaRPr lang="en-US" sz="1800" b="1" dirty="0">
                        <a:solidFill>
                          <a:schemeClr val="accent2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34686" marR="34686" marT="0" marB="0"/>
                </a:tc>
                <a:extLst>
                  <a:ext uri="{0D108BD9-81ED-4DB2-BD59-A6C34878D82A}">
                    <a16:rowId xmlns:a16="http://schemas.microsoft.com/office/drawing/2014/main" val="22584081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155499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>
                <a:latin typeface="Calibri" panose="020F0502020204030204" pitchFamily="34" charset="0"/>
                <a:cs typeface="Calibri" panose="020F0502020204030204" pitchFamily="34" charset="0"/>
              </a:rPr>
              <a:t>CONCLUSIONS</a:t>
            </a:r>
            <a:endParaRPr lang="en-US" sz="3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Among patients with multivessel disease presenting with STEMI, a strategy of ischemia-guided non-culprit PCI resulted in low ischemia burden, and was non-inferior to a strategy of routine non-culprit vessel PCI in reducing ischemia burden 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>
                <a:latin typeface="Calibri" panose="020F0502020204030204" pitchFamily="34" charset="0"/>
                <a:cs typeface="Calibri" panose="020F0502020204030204" pitchFamily="34" charset="0"/>
              </a:rPr>
              <a:t>Selective non-culprit PCI following STEMI offers the potential for cost-savings, and may be particularly relevant to low-resource setting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85725921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</TotalTime>
  <Words>468</Words>
  <Application>Microsoft Office PowerPoint</Application>
  <PresentationFormat>On-screen Show (4:3)</PresentationFormat>
  <Paragraphs>4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5</vt:i4>
      </vt:variant>
    </vt:vector>
  </HeadingPairs>
  <TitlesOfParts>
    <vt:vector size="13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Ischemia-guided versus routine non-culprit vessel angioplasty for patients with ST segment elevation myocardial infarction and multi-vessel disease - the IAEA SPECT STEMI trial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Karthik Ganesan</cp:lastModifiedBy>
  <cp:revision>107</cp:revision>
  <dcterms:created xsi:type="dcterms:W3CDTF">2011-04-18T21:44:13Z</dcterms:created>
  <dcterms:modified xsi:type="dcterms:W3CDTF">2022-08-30T07:20:30Z</dcterms:modified>
</cp:coreProperties>
</file>